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</p:sldIdLst>
  <p:sldSz cy="5943600" cx="146304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/>
</file>

<file path=ppt/tableStyles.xml><?xml version="1.0" encoding="utf-8"?>
<a:tblStyleLst xmlns:a="http://schemas.openxmlformats.org/drawingml/2006/main" xmlns:r="http://schemas.openxmlformats.org/officeDocument/2006/relationships" def="{34D419F9-99DF-45B1-A9AF-6086D482B9DC}">
  <a:tblStyle styleId="{34D419F9-99DF-45B1-A9AF-6086D482B9DC}" styleName="Table_0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Blank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2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2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2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Vertical Text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1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1"/>
          <p:cNvSpPr txBox="1"/>
          <p:nvPr>
            <p:ph idx="1" type="body"/>
          </p:nvPr>
        </p:nvSpPr>
        <p:spPr>
          <a:xfrm rot="5400000">
            <a:off x="5429619" y="-2841572"/>
            <a:ext cx="3771160" cy="1261872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1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1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1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Vertical Title and Text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/>
          <p:nvPr>
            <p:ph type="title"/>
          </p:nvPr>
        </p:nvSpPr>
        <p:spPr>
          <a:xfrm rot="5400000">
            <a:off x="9528756" y="1257565"/>
            <a:ext cx="5036926" cy="315468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2"/>
          <p:cNvSpPr txBox="1"/>
          <p:nvPr>
            <p:ph idx="1" type="body"/>
          </p:nvPr>
        </p:nvSpPr>
        <p:spPr>
          <a:xfrm rot="5400000">
            <a:off x="3127957" y="-1805675"/>
            <a:ext cx="5036926" cy="928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2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2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2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/>
          <p:nvPr>
            <p:ph type="ctrTitle"/>
          </p:nvPr>
        </p:nvSpPr>
        <p:spPr>
          <a:xfrm>
            <a:off x="1828800" y="972715"/>
            <a:ext cx="10972800" cy="2069253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200"/>
              <a:buFont typeface="Calibri"/>
              <a:buNone/>
              <a:defRPr sz="5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3"/>
          <p:cNvSpPr txBox="1"/>
          <p:nvPr>
            <p:ph idx="1" type="subTitle"/>
          </p:nvPr>
        </p:nvSpPr>
        <p:spPr>
          <a:xfrm>
            <a:off x="1828800" y="3121766"/>
            <a:ext cx="10972800" cy="143499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algn="ctr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080"/>
              <a:buNone/>
              <a:defRPr sz="2080"/>
            </a:lvl1pPr>
            <a:lvl2pPr lvl="1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None/>
              <a:defRPr sz="1733"/>
            </a:lvl2pPr>
            <a:lvl3pPr lvl="2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None/>
              <a:defRPr sz="1560"/>
            </a:lvl3pPr>
            <a:lvl4pPr lvl="3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4pPr>
            <a:lvl5pPr lvl="4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5pPr>
            <a:lvl6pPr lvl="5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6pPr>
            <a:lvl7pPr lvl="6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7pPr>
            <a:lvl8pPr lvl="7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8pPr>
            <a:lvl9pPr lvl="8" algn="ctr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9pPr>
          </a:lstStyle>
          <a:p/>
        </p:txBody>
      </p:sp>
      <p:sp>
        <p:nvSpPr>
          <p:cNvPr id="18" name="Google Shape;18;p3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3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3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4"/>
          <p:cNvSpPr txBox="1"/>
          <p:nvPr>
            <p:ph idx="1" type="body"/>
          </p:nvPr>
        </p:nvSpPr>
        <p:spPr>
          <a:xfrm>
            <a:off x="1005840" y="1582208"/>
            <a:ext cx="12618721" cy="377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4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4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4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Section Header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/>
          <p:nvPr>
            <p:ph type="title"/>
          </p:nvPr>
        </p:nvSpPr>
        <p:spPr>
          <a:xfrm>
            <a:off x="998220" y="1481773"/>
            <a:ext cx="12618721" cy="247237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200"/>
              <a:buFont typeface="Calibri"/>
              <a:buNone/>
              <a:defRPr sz="5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5"/>
          <p:cNvSpPr txBox="1"/>
          <p:nvPr>
            <p:ph idx="1" type="body"/>
          </p:nvPr>
        </p:nvSpPr>
        <p:spPr>
          <a:xfrm>
            <a:off x="998220" y="3977535"/>
            <a:ext cx="12618721" cy="13001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rgbClr val="888888"/>
              </a:buClr>
              <a:buSzPts val="2080"/>
              <a:buNone/>
              <a:defRPr sz="208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733"/>
              <a:buNone/>
              <a:defRPr sz="1733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560"/>
              <a:buNone/>
              <a:defRPr sz="156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rgbClr val="888888"/>
              </a:buClr>
              <a:buSzPts val="1387"/>
              <a:buNone/>
              <a:defRPr sz="1387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5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5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5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wo Content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6"/>
          <p:cNvSpPr txBox="1"/>
          <p:nvPr>
            <p:ph idx="1" type="body"/>
          </p:nvPr>
        </p:nvSpPr>
        <p:spPr>
          <a:xfrm>
            <a:off x="1005840" y="1582208"/>
            <a:ext cx="6217920" cy="377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6"/>
          <p:cNvSpPr txBox="1"/>
          <p:nvPr>
            <p:ph idx="2" type="body"/>
          </p:nvPr>
        </p:nvSpPr>
        <p:spPr>
          <a:xfrm>
            <a:off x="7406640" y="1582208"/>
            <a:ext cx="6217920" cy="377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6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6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6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Compariso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/>
          <p:nvPr>
            <p:ph type="title"/>
          </p:nvPr>
        </p:nvSpPr>
        <p:spPr>
          <a:xfrm>
            <a:off x="1007746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7"/>
          <p:cNvSpPr txBox="1"/>
          <p:nvPr>
            <p:ph idx="1" type="body"/>
          </p:nvPr>
        </p:nvSpPr>
        <p:spPr>
          <a:xfrm>
            <a:off x="1007746" y="1457008"/>
            <a:ext cx="6189344" cy="71405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080"/>
              <a:buNone/>
              <a:defRPr b="1" sz="2080"/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None/>
              <a:defRPr b="1" sz="1733"/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None/>
              <a:defRPr b="1" sz="1560"/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9pPr>
          </a:lstStyle>
          <a:p/>
        </p:txBody>
      </p:sp>
      <p:sp>
        <p:nvSpPr>
          <p:cNvPr id="43" name="Google Shape;43;p7"/>
          <p:cNvSpPr txBox="1"/>
          <p:nvPr>
            <p:ph idx="2" type="body"/>
          </p:nvPr>
        </p:nvSpPr>
        <p:spPr>
          <a:xfrm>
            <a:off x="1007746" y="2171065"/>
            <a:ext cx="6189344" cy="319331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7"/>
          <p:cNvSpPr txBox="1"/>
          <p:nvPr>
            <p:ph idx="3" type="body"/>
          </p:nvPr>
        </p:nvSpPr>
        <p:spPr>
          <a:xfrm>
            <a:off x="7406640" y="1457008"/>
            <a:ext cx="6219826" cy="71405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080"/>
              <a:buNone/>
              <a:defRPr b="1" sz="2080"/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None/>
              <a:defRPr b="1" sz="1733"/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None/>
              <a:defRPr b="1" sz="1560"/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b="1" sz="1387"/>
            </a:lvl9pPr>
          </a:lstStyle>
          <a:p/>
        </p:txBody>
      </p:sp>
      <p:sp>
        <p:nvSpPr>
          <p:cNvPr id="45" name="Google Shape;45;p7"/>
          <p:cNvSpPr txBox="1"/>
          <p:nvPr>
            <p:ph idx="4" type="body"/>
          </p:nvPr>
        </p:nvSpPr>
        <p:spPr>
          <a:xfrm>
            <a:off x="7406640" y="2171065"/>
            <a:ext cx="6219826" cy="319331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429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7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7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7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Title Only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8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8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8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Content with Caption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/>
          <p:nvPr>
            <p:ph type="title"/>
          </p:nvPr>
        </p:nvSpPr>
        <p:spPr>
          <a:xfrm>
            <a:off x="1007746" y="396240"/>
            <a:ext cx="4718684" cy="138684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73"/>
              <a:buFont typeface="Calibri"/>
              <a:buNone/>
              <a:defRPr sz="2773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9"/>
          <p:cNvSpPr txBox="1"/>
          <p:nvPr>
            <p:ph idx="1" type="body"/>
          </p:nvPr>
        </p:nvSpPr>
        <p:spPr>
          <a:xfrm>
            <a:off x="6219826" y="855769"/>
            <a:ext cx="7406640" cy="422380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404685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773"/>
              <a:buChar char="•"/>
              <a:defRPr sz="2773"/>
            </a:lvl1pPr>
            <a:lvl2pPr indent="-382714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427"/>
              <a:buChar char="•"/>
              <a:defRPr sz="2427"/>
            </a:lvl2pPr>
            <a:lvl3pPr indent="-36068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080"/>
              <a:buChar char="•"/>
              <a:defRPr sz="2080"/>
            </a:lvl3pPr>
            <a:lvl4pPr indent="-338645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4pPr>
            <a:lvl5pPr indent="-338645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5pPr>
            <a:lvl6pPr indent="-338645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6pPr>
            <a:lvl7pPr indent="-338645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7pPr>
            <a:lvl8pPr indent="-338645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8pPr>
            <a:lvl9pPr indent="-338645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Char char="•"/>
              <a:defRPr sz="1733"/>
            </a:lvl9pPr>
          </a:lstStyle>
          <a:p/>
        </p:txBody>
      </p:sp>
      <p:sp>
        <p:nvSpPr>
          <p:cNvPr id="57" name="Google Shape;57;p9"/>
          <p:cNvSpPr txBox="1"/>
          <p:nvPr>
            <p:ph idx="2" type="body"/>
          </p:nvPr>
        </p:nvSpPr>
        <p:spPr>
          <a:xfrm>
            <a:off x="1007746" y="1783080"/>
            <a:ext cx="4718684" cy="330337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213"/>
              <a:buNone/>
              <a:defRPr sz="1213"/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040"/>
              <a:buNone/>
              <a:defRPr sz="1040"/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9pPr>
          </a:lstStyle>
          <a:p/>
        </p:txBody>
      </p:sp>
      <p:sp>
        <p:nvSpPr>
          <p:cNvPr id="58" name="Google Shape;58;p9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9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9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matchingName="Picture with Caption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0"/>
          <p:cNvSpPr txBox="1"/>
          <p:nvPr>
            <p:ph type="title"/>
          </p:nvPr>
        </p:nvSpPr>
        <p:spPr>
          <a:xfrm>
            <a:off x="1007746" y="396240"/>
            <a:ext cx="4718684" cy="138684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773"/>
              <a:buFont typeface="Calibri"/>
              <a:buNone/>
              <a:defRPr sz="2773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0"/>
          <p:cNvSpPr/>
          <p:nvPr>
            <p:ph idx="2" type="pic"/>
          </p:nvPr>
        </p:nvSpPr>
        <p:spPr>
          <a:xfrm>
            <a:off x="6219826" y="855769"/>
            <a:ext cx="7406640" cy="422380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773"/>
              <a:buFont typeface="Arial"/>
              <a:buNone/>
              <a:defRPr b="0" i="0" sz="277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427"/>
              <a:buFont typeface="Arial"/>
              <a:buNone/>
              <a:defRPr b="0" i="0" sz="2427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080"/>
              <a:buFont typeface="Arial"/>
              <a:buNone/>
              <a:defRPr b="0" i="0" sz="208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None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64" name="Google Shape;64;p10"/>
          <p:cNvSpPr txBox="1"/>
          <p:nvPr>
            <p:ph idx="1" type="body"/>
          </p:nvPr>
        </p:nvSpPr>
        <p:spPr>
          <a:xfrm>
            <a:off x="1007746" y="1783080"/>
            <a:ext cx="4718684" cy="3303376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1387"/>
              <a:buNone/>
              <a:defRPr sz="1387"/>
            </a:lvl1pPr>
            <a:lvl2pPr indent="-228600" lvl="1" marL="914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213"/>
              <a:buNone/>
              <a:defRPr sz="1213"/>
            </a:lvl2pPr>
            <a:lvl3pPr indent="-228600" lvl="2" marL="1371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040"/>
              <a:buNone/>
              <a:defRPr sz="1040"/>
            </a:lvl3pPr>
            <a:lvl4pPr indent="-228600" lvl="3" marL="1828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4pPr>
            <a:lvl5pPr indent="-228600" lvl="4" marL="22860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5pPr>
            <a:lvl6pPr indent="-228600" lvl="5" marL="27432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6pPr>
            <a:lvl7pPr indent="-228600" lvl="6" marL="32004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7pPr>
            <a:lvl8pPr indent="-228600" lvl="7" marL="36576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8pPr>
            <a:lvl9pPr indent="-228600" lvl="8" marL="411480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867"/>
              <a:buNone/>
              <a:defRPr sz="867"/>
            </a:lvl9pPr>
          </a:lstStyle>
          <a:p/>
        </p:txBody>
      </p:sp>
      <p:sp>
        <p:nvSpPr>
          <p:cNvPr id="65" name="Google Shape;65;p10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0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0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1005840" y="316442"/>
            <a:ext cx="12618721" cy="1148821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813"/>
              <a:buFont typeface="Calibri"/>
              <a:buNone/>
              <a:defRPr b="0" i="0" sz="381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1005840" y="1582208"/>
            <a:ext cx="12618721" cy="377116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382714" lvl="0" marL="457200" marR="0" rtl="0" algn="l">
              <a:lnSpc>
                <a:spcPct val="90000"/>
              </a:lnSpc>
              <a:spcBef>
                <a:spcPts val="867"/>
              </a:spcBef>
              <a:spcAft>
                <a:spcPts val="0"/>
              </a:spcAft>
              <a:buClr>
                <a:schemeClr val="dk1"/>
              </a:buClr>
              <a:buSzPts val="2427"/>
              <a:buFont typeface="Arial"/>
              <a:buChar char="•"/>
              <a:defRPr b="0" i="0" sz="2427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60680" lvl="1" marL="9144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2080"/>
              <a:buFont typeface="Arial"/>
              <a:buChar char="•"/>
              <a:defRPr b="0" i="0" sz="208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38645" lvl="2" marL="13716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733"/>
              <a:buFont typeface="Arial"/>
              <a:buChar char="•"/>
              <a:defRPr b="0" i="0" sz="1733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27660" lvl="3" marL="18288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27660" lvl="4" marL="22860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27660" lvl="5" marL="27432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27660" lvl="6" marL="32004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27659" lvl="7" marL="36576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27659" lvl="8" marL="4114800" marR="0" rtl="0" algn="l">
              <a:lnSpc>
                <a:spcPct val="90000"/>
              </a:lnSpc>
              <a:spcBef>
                <a:spcPts val="433"/>
              </a:spcBef>
              <a:spcAft>
                <a:spcPts val="0"/>
              </a:spcAft>
              <a:buClr>
                <a:schemeClr val="dk1"/>
              </a:buClr>
              <a:buSzPts val="1560"/>
              <a:buFont typeface="Arial"/>
              <a:buChar char="•"/>
              <a:defRPr b="0" i="0" sz="156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0" type="dt"/>
          </p:nvPr>
        </p:nvSpPr>
        <p:spPr>
          <a:xfrm>
            <a:off x="100584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1"/>
          <p:cNvSpPr txBox="1"/>
          <p:nvPr>
            <p:ph idx="11" type="ftr"/>
          </p:nvPr>
        </p:nvSpPr>
        <p:spPr>
          <a:xfrm>
            <a:off x="4846320" y="5508837"/>
            <a:ext cx="493776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1"/>
          <p:cNvSpPr txBox="1"/>
          <p:nvPr>
            <p:ph idx="12" type="sldNum"/>
          </p:nvPr>
        </p:nvSpPr>
        <p:spPr>
          <a:xfrm>
            <a:off x="10332720" y="5508837"/>
            <a:ext cx="3291840" cy="316442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04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3"/>
          <p:cNvSpPr txBox="1"/>
          <p:nvPr/>
        </p:nvSpPr>
        <p:spPr>
          <a:xfrm>
            <a:off x="56750" y="300943"/>
            <a:ext cx="226031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a</a:t>
            </a:r>
            <a:endParaRPr/>
          </a:p>
        </p:txBody>
      </p:sp>
      <p:sp>
        <p:nvSpPr>
          <p:cNvPr id="85" name="Google Shape;85;p13"/>
          <p:cNvSpPr txBox="1"/>
          <p:nvPr/>
        </p:nvSpPr>
        <p:spPr>
          <a:xfrm>
            <a:off x="4684889" y="300943"/>
            <a:ext cx="226031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b</a:t>
            </a:r>
            <a:endParaRPr/>
          </a:p>
        </p:txBody>
      </p:sp>
      <p:pic>
        <p:nvPicPr>
          <p:cNvPr id="86" name="Google Shape;86;p1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82781" y="9246"/>
            <a:ext cx="4402108" cy="591887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87" name="Google Shape;87;p13"/>
          <p:cNvGraphicFramePr/>
          <p:nvPr/>
        </p:nvGraphicFramePr>
        <p:xfrm>
          <a:off x="4684889" y="852011"/>
          <a:ext cx="3000000" cy="3000000"/>
        </p:xfrm>
        <a:graphic>
          <a:graphicData uri="http://schemas.openxmlformats.org/drawingml/2006/table">
            <a:tbl>
              <a:tblPr>
                <a:noFill/>
                <a:tableStyleId>{34D419F9-99DF-45B1-A9AF-6086D482B9DC}</a:tableStyleId>
              </a:tblPr>
              <a:tblGrid>
                <a:gridCol w="1020800"/>
                <a:gridCol w="977350"/>
                <a:gridCol w="1009950"/>
                <a:gridCol w="862100"/>
                <a:gridCol w="713125"/>
                <a:gridCol w="1584900"/>
                <a:gridCol w="1042525"/>
                <a:gridCol w="1216275"/>
                <a:gridCol w="1281425"/>
              </a:tblGrid>
              <a:tr h="5548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omosome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osition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redicted Impac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eference Allele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lternate Allele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redicted Effec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% Homozygous Reference</a:t>
                      </a:r>
                      <a:r>
                        <a:rPr b="1" baseline="3000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</a:t>
                      </a: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% Heterozygous Lines</a:t>
                      </a:r>
                      <a:r>
                        <a:rPr b="1" baseline="3000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</a:t>
                      </a:r>
                      <a:endParaRPr b="1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% Homozygous Alternate</a:t>
                      </a:r>
                      <a:r>
                        <a:rPr b="1" baseline="3000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</a:t>
                      </a:r>
                      <a:endParaRPr b="1" i="0" sz="1100" u="none" cap="none" strike="noStrike">
                        <a:solidFill>
                          <a:srgbClr val="000000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2463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ERATE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issense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4.1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.7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4.0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4154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IFIER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TTA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ntron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1.8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.8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5.2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4195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IFIER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ntron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0.9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.4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7.4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4202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IFIER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Intron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3.7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.3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2.7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4404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LOW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TA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lice region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68.0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.4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6.5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4507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IGH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top los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.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4.8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4672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LOW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plice region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0.9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8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.0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5023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IFIER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' UTR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2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.5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9.0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5032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IFIER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' UTR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0.9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8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.0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5654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IFIER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' UTR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5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2.2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9.0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5834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IFIER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' UTR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80.7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.1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8.0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9D9D9"/>
                    </a:solidFill>
                  </a:tcPr>
                </a:tc>
              </a:tr>
              <a:tr h="3065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hr0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40316602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ODIFIER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ACG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3' UTR variant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90.6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1.1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7.7</a:t>
                      </a:r>
                      <a:endParaRPr/>
                    </a:p>
                  </a:txBody>
                  <a:tcPr marT="9525" marB="0" marR="9525" marL="9525" anchor="b">
                    <a:lnL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